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6" d="100"/>
          <a:sy n="76" d="100"/>
        </p:scale>
        <p:origin x="741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C5C9196-5D5D-0967-E78A-0CA43B0A269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136E1191-92EA-1184-8AAE-E5805299C8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A75735-E4D4-D96F-C107-DD723A600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121BE7A-6728-962A-8E51-25133770D0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8BAF466-8A57-795B-E083-FAFC4531A6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7322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45C1B2-7FAB-E5CE-1C1D-3A08E52EE7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47E5A0C3-169E-7DA0-4E97-85EE92B818D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619FF42-4102-7E64-7F89-462793B05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410E85E-F6B9-BA61-0C8B-B4F7DC49E2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02549F1-2B5B-24D6-83BF-2FE339603A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787520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EC3534A4-96ED-8C29-8888-251254379D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D66C483-F1A1-B23B-7998-45F57BE39D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639CCEB-2AFB-BDEF-A54A-C443071282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8E8C2DA-441F-9B74-D68B-427FEC9638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034E136-7720-D6B4-537E-CDD94D41D9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955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BDB216F-A58F-892F-B884-AE9E582692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E1DC940-3084-6DF2-0D0D-75ED4589901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4DF3E3E-038C-7C1D-15BF-111D9E7E4C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5A4B5A7-FF93-4816-DA91-058E6C72D1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D7A5365-B8F7-E2A2-F146-03EC7FA3AD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75633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7BD2618-D222-3A30-7A84-8CD423A364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A37843F-27B1-E495-B2AC-9AD54618C7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223DF26-E638-160B-C44B-8E494B3268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77CEE03-47A6-1425-623E-9AA5A9E6D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9D06B25-D50F-AC7B-8622-473239B5D2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524809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4192250-F63F-AB00-A2CA-E8BEDEC774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2877D9F-E137-ABFD-FAB7-6695C245BDD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B29959D-FFB2-9610-9ABA-C76A728B81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0136EE2-E1B5-2068-E531-3F6F9EA8CE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A5BF1D3-3730-BC78-9151-29122A1F50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240BD9A-3299-1C7F-CD2F-00ECDB3E2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852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1866F17-8DFE-5338-5219-D0B1989373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C57995C-C0C3-B465-5227-9427D0689DC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9831886-B100-3FAB-A419-B10DF38610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BC416A6-DC62-4B3B-DCBD-966D23B1FD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12F84B8-D946-C05A-58F5-AB2857F2857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DC1D156E-5904-5317-1F90-09368E4745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309B222-C771-12AC-9316-BA9717C42C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0929706-90AF-F25F-2C19-E63C6A9265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44850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528D8C-CF1F-E332-F8E3-BF7B0AE302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223881B-005D-3F30-6B18-523917E833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E91DCE5E-5887-5562-869C-4C31B00FE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7488E12-4617-FF2F-3634-8D3E366EE6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44478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2A125B5-C95C-D77B-C707-1C227789AC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71CC1E60-746E-4CED-61BC-812308DA21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5D0B74A-5FC4-63F0-7851-9FB85F32E3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66256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3819A2B-39FC-EC76-491B-B42016D64A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F017F7B-128B-6E96-10B4-6BE86BFA0E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0F48A91-5601-104F-65EF-792F8DAD1F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863BAD4-0B77-F2C4-1549-F26AA838D4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D0D7978-B2A9-C806-AAAD-47E9A1376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146E2DE-F4C1-F45D-725F-37892A94C1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05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C2FFA7-8051-AB8F-15C9-7A54DD0EAC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9C846B1-FFCD-A536-E916-557A2D9CA87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601EAD1-FDC5-BC2C-1E9F-F5F1CD51674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8266B09-6F58-48D3-9D0F-4A7423492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D958D29-F492-5646-5F2B-00208DD176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F4E0761-AD27-CCE3-9385-E96DD81F16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773737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079C2D0-D267-8453-19A5-4113BFF4F9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6AE921F-2FA8-4647-0859-B2D700ADA7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6F19559-6CEB-B4D9-561A-8E4D656B2A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F4B3F-FF10-43A3-ADB3-1DD6C0D9FB2B}" type="datetimeFigureOut">
              <a:rPr lang="zh-CN" altLang="en-US" smtClean="0"/>
              <a:t>2024/11/3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F7F91A4-3D63-8217-4754-7A919704BC0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B750527-96BE-63F8-B34D-DD551D9C738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4CA00D-A462-4590-A594-AC3CA2DDDD0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18003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56496153-076C-233E-C9BE-FE6CC4808BE4}"/>
              </a:ext>
            </a:extLst>
          </p:cNvPr>
          <p:cNvSpPr txBox="1"/>
          <p:nvPr/>
        </p:nvSpPr>
        <p:spPr>
          <a:xfrm>
            <a:off x="2989800" y="5598835"/>
            <a:ext cx="82494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/>
              <a:t>Supplementary figure1 Recombinant pcDNA3.1-SSR4 vector map</a:t>
            </a:r>
            <a:endParaRPr lang="zh-CN" altLang="en-US" sz="1200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8C2BA62A-5BC2-F390-DAEA-7EAED9B8EC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33600" y="709954"/>
            <a:ext cx="5536800" cy="44493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201844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FD743E40-2F4D-F9E2-4044-49C94FE59281}"/>
              </a:ext>
            </a:extLst>
          </p:cNvPr>
          <p:cNvSpPr txBox="1"/>
          <p:nvPr/>
        </p:nvSpPr>
        <p:spPr>
          <a:xfrm>
            <a:off x="2615400" y="5591635"/>
            <a:ext cx="75006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200" dirty="0"/>
              <a:t>Supplementary figure 2 Recombinant pcMINI-C-SSR4 vector map</a:t>
            </a:r>
            <a:endParaRPr lang="zh-CN" altLang="en-US" sz="1200" dirty="0"/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DA84B877-A8AB-E790-2DE9-9B3F52209D8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54400" y="703084"/>
            <a:ext cx="5746292" cy="46429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5756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3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qy Bing</dc:creator>
  <cp:lastModifiedBy>qy Bing</cp:lastModifiedBy>
  <cp:revision>2</cp:revision>
  <dcterms:created xsi:type="dcterms:W3CDTF">2024-11-03T12:01:45Z</dcterms:created>
  <dcterms:modified xsi:type="dcterms:W3CDTF">2024-11-03T12:05:19Z</dcterms:modified>
</cp:coreProperties>
</file>